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FD97869-3F93-491D-9FDD-433DB48DE805}" v="1" dt="2025-10-30T16:08:02.80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>
      <p:cViewPr>
        <p:scale>
          <a:sx n="66" d="100"/>
          <a:sy n="66" d="100"/>
        </p:scale>
        <p:origin x="62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emertzidou, Anysia" userId="a7f71f62-1794-4728-88f7-f0b545a7c8aa" providerId="ADAL" clId="{EFD97869-3F93-491D-9FDD-433DB48DE805}"/>
    <pc:docChg chg="modSld">
      <pc:chgData name="Semertzidou, Anysia" userId="a7f71f62-1794-4728-88f7-f0b545a7c8aa" providerId="ADAL" clId="{EFD97869-3F93-491D-9FDD-433DB48DE805}" dt="2025-10-30T16:08:43.855" v="18" actId="113"/>
      <pc:docMkLst>
        <pc:docMk/>
      </pc:docMkLst>
      <pc:sldChg chg="addSp modSp mod">
        <pc:chgData name="Semertzidou, Anysia" userId="a7f71f62-1794-4728-88f7-f0b545a7c8aa" providerId="ADAL" clId="{EFD97869-3F93-491D-9FDD-433DB48DE805}" dt="2025-10-30T16:08:43.855" v="18" actId="113"/>
        <pc:sldMkLst>
          <pc:docMk/>
          <pc:sldMk cId="1462173143" sldId="256"/>
        </pc:sldMkLst>
        <pc:spChg chg="add mod">
          <ac:chgData name="Semertzidou, Anysia" userId="a7f71f62-1794-4728-88f7-f0b545a7c8aa" providerId="ADAL" clId="{EFD97869-3F93-491D-9FDD-433DB48DE805}" dt="2025-10-30T16:08:27.974" v="15" actId="1076"/>
          <ac:spMkLst>
            <pc:docMk/>
            <pc:sldMk cId="1462173143" sldId="256"/>
            <ac:spMk id="2" creationId="{D9F173AA-4535-B72E-5F01-7AEAFB625DCB}"/>
          </ac:spMkLst>
        </pc:spChg>
        <pc:spChg chg="add mod">
          <ac:chgData name="Semertzidou, Anysia" userId="a7f71f62-1794-4728-88f7-f0b545a7c8aa" providerId="ADAL" clId="{EFD97869-3F93-491D-9FDD-433DB48DE805}" dt="2025-10-30T16:08:43.855" v="18" actId="113"/>
          <ac:spMkLst>
            <pc:docMk/>
            <pc:sldMk cId="1462173143" sldId="256"/>
            <ac:spMk id="5" creationId="{D7947428-3265-90D4-2C4E-CF914CF3E51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AFDE73-2CBA-CE9A-BEFE-3334ADB7DD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214A39-58AA-91C5-B5B5-347F6F0FE3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960228-C523-FE4F-6765-F0BED01B8E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DCB30-BE44-4FBC-AA41-1646EFCB6E6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B9D24C-63A5-2D46-F9EA-C53EF4CB5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0C0AE0-0A58-EF19-1F72-171761C936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1969A-0E47-44EC-B254-42D86EB08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507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BDEA1B-9DFC-C5B9-A154-FFBC3906AC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624165-4CAC-634E-2F44-8D8A4BFE4E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DF17B5-DD13-7DBE-29AB-0187C23BEF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DCB30-BE44-4FBC-AA41-1646EFCB6E6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BEE5A6-B3FF-D452-99E9-347FCE511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FEB27A-C1C5-0D87-E305-3F0C6AADFC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1969A-0E47-44EC-B254-42D86EB08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1202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F028153-98F2-D94C-7EA6-0680491ACE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959ECFC-D769-9110-4674-288C474B64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5CDF1F-C017-2D68-B60E-6EA10B649D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DCB30-BE44-4FBC-AA41-1646EFCB6E6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15B341-7E51-21E9-9B41-497796C32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CA341C-6B9B-CCB2-6AF4-25FE589DE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1969A-0E47-44EC-B254-42D86EB08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0195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E90BD2-63BD-4EE6-0720-93C0D099DE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49EFEB-A99D-23D5-762B-42EE0DD1BD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4EB3BF-C818-FED2-A719-71E04D3332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DCB30-BE44-4FBC-AA41-1646EFCB6E6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FFF549-5BD4-594A-E6FB-402C54F86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E9DFAD-8E07-BCD7-DB2F-882929C992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1969A-0E47-44EC-B254-42D86EB08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5779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18CD94-2B49-BAC6-6094-7EABB58CD7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C03986-2700-5550-8573-949C31A059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99DC47-AD10-DB28-DF16-F97174BDB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DCB30-BE44-4FBC-AA41-1646EFCB6E6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704EE6-209F-E65F-2EF6-20913CBE9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BC7A19-C068-251D-D949-A2393BBB3C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1969A-0E47-44EC-B254-42D86EB08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1208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41B9D7-E6B3-DEEF-75D3-09A04CF0C1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56EA9E-1F24-4E6B-EAED-D711B95542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C8EEDD-3FE7-EA29-E83B-7E9C4607D5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B2C2BC-07A7-48A4-F1EC-CDE37FC859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DCB30-BE44-4FBC-AA41-1646EFCB6E6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754393-46CC-2DA5-E83B-CC10C86B66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86A0B0-ED24-0DC8-D5A5-68B835D0B2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1969A-0E47-44EC-B254-42D86EB08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6963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60AAF1-304D-8C2A-47C8-D76B609462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E7840F-7663-E18C-19A7-4F19F3DB14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8C8178-F68F-897C-D773-ABB0EC7966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5F79A82-4A82-AB4C-1DD5-BBE4009619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716710D-8C3B-CB26-B877-703FCFD9EE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05AAC30-64D8-727F-891B-CE4E6098EE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DCB30-BE44-4FBC-AA41-1646EFCB6E6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A52553E-9891-EC86-F6BD-79BA9B4B7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D1ED016-16A4-C592-1DEB-4806F9A05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1969A-0E47-44EC-B254-42D86EB08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35344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2044B7-F083-298A-CC41-0658CA70B0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8D405F3-9BF0-2DF5-D88B-310457078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DCB30-BE44-4FBC-AA41-1646EFCB6E6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DE0364B-414B-2E42-465B-FCE44A678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69CFC63-523F-6B9C-9FD0-1983536D9A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1969A-0E47-44EC-B254-42D86EB08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22109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004FC0C-F1FA-6254-7622-596A00164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DCB30-BE44-4FBC-AA41-1646EFCB6E6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051600C-A41B-BB0B-F33A-559F726EB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3EF9FA2-B9D5-A702-CBF7-7F40782D6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1969A-0E47-44EC-B254-42D86EB08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2837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B331BF-A373-16BC-383A-F62F3CEDFF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60EAA7-6359-3254-251F-21BA2A9639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3A68B2-B354-4794-5FB1-C9765E0D0E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2B9F55-B38B-6A3F-12E5-7A57DED4F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DCB30-BE44-4FBC-AA41-1646EFCB6E6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456A44-1952-1F03-84B0-BEA0F34B1C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5F0509-A2CF-59C0-E749-489802FFC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1969A-0E47-44EC-B254-42D86EB08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3337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17E2BB-F135-C1DA-6BE5-FFABFE9B68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2474779-44A6-5D6D-0A68-894DA5EF70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532A50-C9BF-51FA-9F6B-BAAF2DFB8C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1148F24-E06A-915F-082B-B77EBAA520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DCB30-BE44-4FBC-AA41-1646EFCB6E6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23FA3C-784A-9028-9B39-76EF584EAE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23948C-7BAA-5430-FAA7-75D91FB3B9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1969A-0E47-44EC-B254-42D86EB08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9304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83CFD9-6E31-3488-F85F-C6E7B1CB71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1CE8EC-AB2B-FD49-BB58-8772F2C36F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4D3F74-64CB-AA19-0421-F1145B8E6B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C5DCB30-BE44-4FBC-AA41-1646EFCB6E6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8E9600-0DC7-212B-4DA0-C7028B21B3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E7BD71-0CAA-4D60-0377-80485A1FB8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EC1969A-0E47-44EC-B254-42D86EB08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8207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graph&#10;&#10;Description automatically generated">
            <a:extLst>
              <a:ext uri="{FF2B5EF4-FFF2-40B4-BE49-F238E27FC236}">
                <a16:creationId xmlns:a16="http://schemas.microsoft.com/office/drawing/2014/main" id="{7BF87681-2DD3-51EF-0390-8D878E53E18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0245" y="1176338"/>
            <a:ext cx="5731510" cy="4505325"/>
          </a:xfrm>
          <a:prstGeom prst="rect">
            <a:avLst/>
          </a:prstGeom>
        </p:spPr>
      </p:pic>
      <p:sp>
        <p:nvSpPr>
          <p:cNvPr id="2" name="Text Box 343971001">
            <a:extLst>
              <a:ext uri="{FF2B5EF4-FFF2-40B4-BE49-F238E27FC236}">
                <a16:creationId xmlns:a16="http://schemas.microsoft.com/office/drawing/2014/main" id="{D9F173AA-4535-B72E-5F01-7AEAFB625DCB}"/>
              </a:ext>
            </a:extLst>
          </p:cNvPr>
          <p:cNvSpPr>
            <a:spLocks noChangeArrowheads="1"/>
          </p:cNvSpPr>
          <p:nvPr/>
        </p:nvSpPr>
        <p:spPr>
          <a:xfrm>
            <a:off x="2955038" y="5958272"/>
            <a:ext cx="7064860" cy="262892"/>
          </a:xfrm>
          <a:prstGeom prst="rect">
            <a:avLst/>
          </a:prstGeom>
          <a:solidFill>
            <a:srgbClr val="FFFFFF"/>
          </a:solidFill>
          <a:ln w="9525">
            <a:noFill/>
            <a:miter/>
          </a:ln>
        </p:spPr>
        <p:txBody>
          <a:bodyPr wrap="square" lIns="91440" tIns="45720" rIns="91440" bIns="45720" anchor="t">
            <a:spAutoFit/>
          </a:bodyPr>
          <a:lstStyle/>
          <a:p>
            <a:pPr algn="just">
              <a:lnSpc>
                <a:spcPct val="105000"/>
              </a:lnSpc>
              <a:spcAft>
                <a:spcPts val="800"/>
              </a:spcAft>
            </a:pPr>
            <a:r>
              <a:rPr lang="en-US" sz="1100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Supplementary Figure 3 shows </a:t>
            </a:r>
            <a:r>
              <a:rPr lang="en-US" sz="1100" i="1" kern="100" dirty="0"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p</a:t>
            </a:r>
            <a:r>
              <a:rPr lang="en-US" sz="1100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lots of T Cell Inhibitor versus Immune Cell density across different regions of the </a:t>
            </a:r>
            <a:r>
              <a:rPr lang="en-US" sz="1100" i="1" kern="100" dirty="0" err="1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tumour</a:t>
            </a:r>
            <a:r>
              <a:rPr lang="en-US" sz="1100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.</a:t>
            </a:r>
            <a:endParaRPr lang="en-GB" sz="1100" kern="1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7947428-3265-90D4-2C4E-CF914CF3E519}"/>
              </a:ext>
            </a:extLst>
          </p:cNvPr>
          <p:cNvSpPr txBox="1"/>
          <p:nvPr/>
        </p:nvSpPr>
        <p:spPr>
          <a:xfrm>
            <a:off x="3549315" y="619043"/>
            <a:ext cx="60976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Supplementary Figure 3 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462173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3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emertzidou, Anysia</dc:creator>
  <cp:lastModifiedBy>Semertzidou, Anysia</cp:lastModifiedBy>
  <cp:revision>1</cp:revision>
  <dcterms:created xsi:type="dcterms:W3CDTF">2025-10-06T13:31:03Z</dcterms:created>
  <dcterms:modified xsi:type="dcterms:W3CDTF">2025-10-30T16:08:45Z</dcterms:modified>
</cp:coreProperties>
</file>